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7559675" cy="104394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6" d="100"/>
          <a:sy n="76" d="100"/>
        </p:scale>
        <p:origin x="304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08486"/>
            <a:ext cx="6425724" cy="3634458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483102"/>
            <a:ext cx="5669756" cy="2520438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638A-259E-454B-A348-5E7076D06074}" type="datetimeFigureOut">
              <a:rPr lang="pt-BR" smtClean="0"/>
              <a:t>03/10/20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1E69-6907-4391-899F-2381B2FE57E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292895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638A-259E-454B-A348-5E7076D06074}" type="datetimeFigureOut">
              <a:rPr lang="pt-BR" smtClean="0"/>
              <a:t>03/10/20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1E69-6907-4391-899F-2381B2FE57E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963169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55801"/>
            <a:ext cx="1630055" cy="88469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55801"/>
            <a:ext cx="4795669" cy="884690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638A-259E-454B-A348-5E7076D06074}" type="datetimeFigureOut">
              <a:rPr lang="pt-BR" smtClean="0"/>
              <a:t>03/10/20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1E69-6907-4391-899F-2381B2FE57E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660881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638A-259E-454B-A348-5E7076D06074}" type="datetimeFigureOut">
              <a:rPr lang="pt-BR" smtClean="0"/>
              <a:t>03/10/20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1E69-6907-4391-899F-2381B2FE57E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246690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02603"/>
            <a:ext cx="6520220" cy="4342500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6986185"/>
            <a:ext cx="6520220" cy="2283618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638A-259E-454B-A348-5E7076D06074}" type="datetimeFigureOut">
              <a:rPr lang="pt-BR" smtClean="0"/>
              <a:t>03/10/20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1E69-6907-4391-899F-2381B2FE57E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766838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779007"/>
            <a:ext cx="3212862" cy="66237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779007"/>
            <a:ext cx="3212862" cy="66237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638A-259E-454B-A348-5E7076D06074}" type="datetimeFigureOut">
              <a:rPr lang="pt-BR" smtClean="0"/>
              <a:t>03/10/2018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1E69-6907-4391-899F-2381B2FE57E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690951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55804"/>
            <a:ext cx="6520220" cy="201780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559104"/>
            <a:ext cx="3198096" cy="1254177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813281"/>
            <a:ext cx="3198096" cy="56087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559104"/>
            <a:ext cx="3213847" cy="1254177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813281"/>
            <a:ext cx="3213847" cy="56087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638A-259E-454B-A348-5E7076D06074}" type="datetimeFigureOut">
              <a:rPr lang="pt-BR" smtClean="0"/>
              <a:t>03/10/2018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1E69-6907-4391-899F-2381B2FE57E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257179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638A-259E-454B-A348-5E7076D06074}" type="datetimeFigureOut">
              <a:rPr lang="pt-BR" smtClean="0"/>
              <a:t>03/10/2018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1E69-6907-4391-899F-2381B2FE57E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786785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638A-259E-454B-A348-5E7076D06074}" type="datetimeFigureOut">
              <a:rPr lang="pt-BR" smtClean="0"/>
              <a:t>03/10/2018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1E69-6907-4391-899F-2381B2FE57E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069925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95960"/>
            <a:ext cx="2438192" cy="243586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03083"/>
            <a:ext cx="3827085" cy="7418740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131820"/>
            <a:ext cx="2438192" cy="5802084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638A-259E-454B-A348-5E7076D06074}" type="datetimeFigureOut">
              <a:rPr lang="pt-BR" smtClean="0"/>
              <a:t>03/10/2018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1E69-6907-4391-899F-2381B2FE57E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28760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95960"/>
            <a:ext cx="2438192" cy="243586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03083"/>
            <a:ext cx="3827085" cy="7418740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131820"/>
            <a:ext cx="2438192" cy="5802084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C638A-259E-454B-A348-5E7076D06074}" type="datetimeFigureOut">
              <a:rPr lang="pt-BR" smtClean="0"/>
              <a:t>03/10/2018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01E69-6907-4391-899F-2381B2FE57E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7839639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55804"/>
            <a:ext cx="6520220" cy="20178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779007"/>
            <a:ext cx="6520220" cy="66237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675780"/>
            <a:ext cx="1700927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AC638A-259E-454B-A348-5E7076D06074}" type="datetimeFigureOut">
              <a:rPr lang="pt-BR" smtClean="0"/>
              <a:t>03/10/2018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675780"/>
            <a:ext cx="2551390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675780"/>
            <a:ext cx="1700927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801E69-6907-4391-899F-2381B2FE57E8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010638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E028BD4B-C915-4386-8342-9028954C14DC}"/>
              </a:ext>
            </a:extLst>
          </p:cNvPr>
          <p:cNvSpPr/>
          <p:nvPr/>
        </p:nvSpPr>
        <p:spPr>
          <a:xfrm>
            <a:off x="386930" y="6004146"/>
            <a:ext cx="6785811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Supplementary 2: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Effect of pH on alpha-glucosidase activity using sucrose  as substrate in different feeding conditions and tissues of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L. </a:t>
            </a:r>
            <a:r>
              <a:rPr 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longipalpis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females. Samples were obtained from recently emerged females (0-3 h)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A, D, G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), females fed with sucrose 1.2 M for 2 days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B, E, H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) and females after 2 days of blood feeding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C, F, I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). For each feeding condition, midgut content fraction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A, B, C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), midgut tissue fraction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D, E, F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) and carcass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G, H, I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) were analyzed. The points are experimental results and curves were calculated based on constants computed with the software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Graphit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using equations assuming two ionizable groups. </a:t>
            </a:r>
            <a:endParaRPr lang="pt-BR" sz="12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7D3E6E8-0E1B-4CC1-A06E-CA4C7E1817F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906"/>
          <a:stretch/>
        </p:blipFill>
        <p:spPr>
          <a:xfrm>
            <a:off x="126999" y="0"/>
            <a:ext cx="7264401" cy="60041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05180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135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mara</dc:creator>
  <cp:lastModifiedBy>Samara Costa Latgé</cp:lastModifiedBy>
  <cp:revision>5</cp:revision>
  <dcterms:created xsi:type="dcterms:W3CDTF">2018-04-05T22:29:35Z</dcterms:created>
  <dcterms:modified xsi:type="dcterms:W3CDTF">2018-10-03T23:31:39Z</dcterms:modified>
</cp:coreProperties>
</file>